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64" r:id="rId3"/>
    <p:sldId id="263" r:id="rId4"/>
    <p:sldId id="261" r:id="rId5"/>
    <p:sldId id="262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CA3A"/>
    <a:srgbClr val="0521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30" autoAdjust="0"/>
    <p:restoredTop sz="94660"/>
  </p:normalViewPr>
  <p:slideViewPr>
    <p:cSldViewPr snapToGrid="0">
      <p:cViewPr varScale="1">
        <p:scale>
          <a:sx n="87" d="100"/>
          <a:sy n="87" d="100"/>
        </p:scale>
        <p:origin x="329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57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937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670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967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730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001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453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064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074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830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4165E-80EC-418A-B07E-D86A88F7C440}" type="datetimeFigureOut">
              <a:rPr lang="en-US" smtClean="0"/>
              <a:t>5/1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27F9B-0836-4375-8139-1173DC431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1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40675" y="167792"/>
            <a:ext cx="1747759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877581" y="1233861"/>
            <a:ext cx="2757005" cy="2066802"/>
            <a:chOff x="1847764" y="1989235"/>
            <a:chExt cx="2757005" cy="2066802"/>
          </a:xfrm>
        </p:grpSpPr>
        <p:grpSp>
          <p:nvGrpSpPr>
            <p:cNvPr id="3" name="Group 2"/>
            <p:cNvGrpSpPr/>
            <p:nvPr/>
          </p:nvGrpSpPr>
          <p:grpSpPr>
            <a:xfrm>
              <a:off x="1847764" y="1989235"/>
              <a:ext cx="2757005" cy="2066802"/>
              <a:chOff x="1998302" y="731935"/>
              <a:chExt cx="2757005" cy="2066802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3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433"/>
              <a:stretch/>
            </p:blipFill>
            <p:spPr>
              <a:xfrm flipH="1">
                <a:off x="2245943" y="1393063"/>
                <a:ext cx="1896900" cy="1405674"/>
              </a:xfrm>
              <a:prstGeom prst="rect">
                <a:avLst/>
              </a:prstGeom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2116976" y="921338"/>
                <a:ext cx="65073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rker</a:t>
                </a:r>
              </a:p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kDa)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998302" y="1397201"/>
                <a:ext cx="4196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063739" y="1657108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063739" y="1960562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063739" y="2167285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3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022764" y="1522456"/>
                <a:ext cx="38496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063739" y="1803602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411427" y="731935"/>
                <a:ext cx="8739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p D2-BGL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088909" y="731935"/>
                <a:ext cx="8519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c</a:t>
                </a:r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2-BGL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2694130" y="1140679"/>
                <a:ext cx="38855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3232203" y="1140679"/>
                <a:ext cx="38855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2559456" y="921338"/>
                <a:ext cx="6751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o H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089991" y="921338"/>
                <a:ext cx="6751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o H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851501" y="1057160"/>
                <a:ext cx="2851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b="1" dirty="0">
                    <a:cs typeface="Times New Roman" panose="02020603050405020304" pitchFamily="18" charset="0"/>
                  </a:rPr>
                  <a:t>+</a:t>
                </a:r>
                <a:endParaRPr lang="zh-TW" altLang="en-US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590835" y="1029590"/>
                <a:ext cx="28513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2000" b="1" dirty="0">
                    <a:cs typeface="Times New Roman" panose="02020603050405020304" pitchFamily="18" charset="0"/>
                  </a:rPr>
                  <a:t>-</a:t>
                </a:r>
                <a:endParaRPr lang="zh-TW" altLang="en-US" sz="2000" b="1" dirty="0"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080160" y="2347166"/>
                <a:ext cx="6751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do H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Down Arrow 21"/>
              <p:cNvSpPr/>
              <p:nvPr/>
            </p:nvSpPr>
            <p:spPr>
              <a:xfrm rot="5400000">
                <a:off x="4070146" y="2419737"/>
                <a:ext cx="62604" cy="144833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b="1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062639" y="2340324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062639" y="2530420"/>
                <a:ext cx="35480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TW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  <a:endParaRPr lang="zh-TW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2982661" y="2286890"/>
              <a:ext cx="28513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2000" b="1" dirty="0">
                  <a:cs typeface="Times New Roman" panose="02020603050405020304" pitchFamily="18" charset="0"/>
                </a:rPr>
                <a:t>-</a:t>
              </a:r>
              <a:endParaRPr lang="zh-TW" altLang="en-US" sz="2000" b="1" dirty="0"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61823" y="2308990"/>
              <a:ext cx="2851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b="1" dirty="0">
                  <a:cs typeface="Times New Roman" panose="02020603050405020304" pitchFamily="18" charset="0"/>
                </a:rPr>
                <a:t>+</a:t>
              </a:r>
              <a:endParaRPr lang="zh-TW" altLang="en-US" b="1" dirty="0"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Rectangle 17"/>
          <p:cNvSpPr/>
          <p:nvPr/>
        </p:nvSpPr>
        <p:spPr>
          <a:xfrm>
            <a:off x="919369" y="3456589"/>
            <a:ext cx="5063987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  <a:tabLst>
                <a:tab pos="2781300" algn="r"/>
              </a:tabLst>
            </a:pP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g. S1: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. cerevisiae-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expressed D2-BGL has a higher level of N-glycosylation than that in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. pastoris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-expressed D2-BGL.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. pastoris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-expressed D2-BGL (Pp D2-BGL) and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. cerevisiae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-expressed D2-BGL (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c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D2-BGL) without (-) or with (+)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deglycosylation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treatment by Endoglucanase H  (Endo H) were used to perform the SDS-PAGE analysis. The theoretical molecular weight of D2-BGL (722 amino acid residues) is 76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Da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. One microgram of purified D2-BGL was loaded per well.</a:t>
            </a:r>
          </a:p>
        </p:txBody>
      </p:sp>
    </p:spTree>
    <p:extLst>
      <p:ext uri="{BB962C8B-B14F-4D97-AF65-F5344CB8AC3E}">
        <p14:creationId xmlns:p14="http://schemas.microsoft.com/office/powerpoint/2010/main" val="4517681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0675" y="167792"/>
            <a:ext cx="1747759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sp>
        <p:nvSpPr>
          <p:cNvPr id="4" name="Rectangle 3"/>
          <p:cNvSpPr/>
          <p:nvPr/>
        </p:nvSpPr>
        <p:spPr>
          <a:xfrm>
            <a:off x="1288080" y="3463963"/>
            <a:ext cx="408770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g. S2: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bsitution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of F256 modifies the substrate affinity towards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ellobiose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in D2-BGL. The substrate binding sub-site +1 is formed by W34, Y444 and F256 (stick in orange) in D2-BGL (in grey). In D2-BGL F256Y and F256M mutants, the F256 was substituted by tyrosine Y (stick in green) or by methionine M (stick by blue), respectively. TCB: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hiocellobiose</a:t>
            </a:r>
            <a:endParaRPr lang="en-US" sz="12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3696" y="1066261"/>
            <a:ext cx="3059491" cy="2142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0762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0675" y="167792"/>
            <a:ext cx="1747759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</a:p>
        </p:txBody>
      </p:sp>
      <p:sp>
        <p:nvSpPr>
          <p:cNvPr id="6" name="Rectangle 5"/>
          <p:cNvSpPr/>
          <p:nvPr/>
        </p:nvSpPr>
        <p:spPr>
          <a:xfrm>
            <a:off x="150814" y="839888"/>
            <a:ext cx="5097999" cy="40902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  <a:tabLst>
                <a:tab pos="2781300" algn="r"/>
              </a:tabLst>
            </a:pP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able S1: Mutations generated by error-prone PCR in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ut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A,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ut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B and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ut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C</a:t>
            </a:r>
            <a:endParaRPr lang="en-US" sz="1200" kern="100" dirty="0"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244" y="1776066"/>
            <a:ext cx="4989513" cy="2274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50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140675" y="167792"/>
            <a:ext cx="1747759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  <p:sp>
        <p:nvSpPr>
          <p:cNvPr id="6" name="Rectangle 5"/>
          <p:cNvSpPr/>
          <p:nvPr/>
        </p:nvSpPr>
        <p:spPr>
          <a:xfrm>
            <a:off x="415090" y="6802501"/>
            <a:ext cx="604586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  <a:tabLst>
                <a:tab pos="2781300" algn="r"/>
              </a:tabLst>
            </a:pP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g. S3: Kinetics study of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. pastoris-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expressed D2-BGL with purified WT D2, F256M and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ut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M enzymes. (a and b): Determinations of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</a:t>
            </a:r>
            <a:r>
              <a:rPr lang="en-US" sz="1200" kern="100" baseline="-25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and </a:t>
            </a:r>
            <a:r>
              <a:rPr lang="en-US" sz="1200" i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V</a:t>
            </a:r>
            <a:r>
              <a:rPr lang="en-US" sz="1200" kern="100" baseline="-250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ax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using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ellobiose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or </a:t>
            </a:r>
            <a:r>
              <a:rPr lang="en-US" sz="1200" i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NPG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as substrates. (c and d) Determinations of the inhibition constant of glucose </a:t>
            </a:r>
            <a:r>
              <a:rPr lang="en-US" sz="1200" i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K</a:t>
            </a:r>
            <a:r>
              <a:rPr lang="en-US" sz="1200" kern="100" baseline="-25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i glucose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using </a:t>
            </a:r>
            <a:r>
              <a:rPr lang="en-US" sz="1200" i="1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NPG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as substrate for WT D2 and </a:t>
            </a:r>
            <a:r>
              <a:rPr lang="en-US" sz="1200" kern="100" dirty="0" err="1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Mut</a:t>
            </a: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M. (e) Kinetics model used for substrate inhibition study. Enzyme assays were performed at least in triplicate, and error bars represent the standard deviation.</a:t>
            </a:r>
            <a:endParaRPr lang="en-US" sz="1200" kern="100" dirty="0"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263968" y="1037487"/>
            <a:ext cx="6388338" cy="5392961"/>
            <a:chOff x="263968" y="1037487"/>
            <a:chExt cx="6388338" cy="539296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87" b="10745"/>
            <a:stretch/>
          </p:blipFill>
          <p:spPr>
            <a:xfrm>
              <a:off x="4094018" y="3510795"/>
              <a:ext cx="2466805" cy="199492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76" b="10388"/>
            <a:stretch/>
          </p:blipFill>
          <p:spPr>
            <a:xfrm>
              <a:off x="841664" y="3496384"/>
              <a:ext cx="2476513" cy="2002895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986" b="12649"/>
            <a:stretch/>
          </p:blipFill>
          <p:spPr>
            <a:xfrm>
              <a:off x="4073236" y="1205883"/>
              <a:ext cx="2579070" cy="1897925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75" r="6440" b="10966"/>
            <a:stretch/>
          </p:blipFill>
          <p:spPr>
            <a:xfrm>
              <a:off x="846858" y="1207667"/>
              <a:ext cx="2441655" cy="1928339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63968" y="1037487"/>
              <a:ext cx="298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3968" y="3378848"/>
              <a:ext cx="298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561401" y="1037487"/>
              <a:ext cx="298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561401" y="3378848"/>
              <a:ext cx="298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-416194" y="2007429"/>
              <a:ext cx="171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on velocity (U/L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174695" y="3084496"/>
              <a:ext cx="1750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obiose (mM)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403396" y="3084495"/>
              <a:ext cx="1750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PG (mM)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158231" y="5426096"/>
              <a:ext cx="1750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PG (mM)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386932" y="5458263"/>
              <a:ext cx="1750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PG (mM)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687013" y="6091894"/>
              <a:ext cx="291458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=</a:t>
              </a:r>
              <a:r>
                <a:rPr lang="en-US" sz="16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en-US" sz="1200" baseline="-250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x</a:t>
              </a:r>
              <a:r>
                <a:rPr lang="en-US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(</a:t>
              </a:r>
              <a:r>
                <a:rPr lang="en-US" sz="16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  <a:r>
                <a:rPr lang="en-US" sz="1200" baseline="-25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[S] + 1 + [S]/</a:t>
              </a:r>
              <a:r>
                <a:rPr lang="en-US" sz="16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  <a:r>
                <a:rPr lang="en-US" sz="1200" baseline="-250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substrate</a:t>
              </a:r>
              <a:r>
                <a:rPr lang="en-US" sz="16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63968" y="5797369"/>
              <a:ext cx="298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102295" y="3502742"/>
              <a:ext cx="185307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 effect on WT D2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362496" y="3502742"/>
              <a:ext cx="182070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 effect on 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ut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736668" y="1492045"/>
              <a:ext cx="60837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D2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734211" y="1673942"/>
              <a:ext cx="5719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ut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013717" y="1298728"/>
              <a:ext cx="590943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D2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021763" y="1473592"/>
              <a:ext cx="59047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ut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21763" y="1663962"/>
              <a:ext cx="59047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256M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2824918" y="2007429"/>
              <a:ext cx="171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on velocity (U/L)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-418338" y="4490896"/>
              <a:ext cx="171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on velocity (U/L)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2822774" y="4490896"/>
              <a:ext cx="17160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ction velocity (U/L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38602" y="1278083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38602" y="1768188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38602" y="2261756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38602" y="2757056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782297" y="1279814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782297" y="1577690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782297" y="2455710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782297" y="2763982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782297" y="1868631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782297" y="2166507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50724" y="3747651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50724" y="4092291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50724" y="4435194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50724" y="5122719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50724" y="4774632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794420" y="3766718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794420" y="4223916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794420" y="5140036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794420" y="4677654"/>
              <a:ext cx="384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60748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0675" y="167792"/>
            <a:ext cx="1747759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</a:p>
          <a:p>
            <a:r>
              <a:rPr lang="en-US" sz="1125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</a:p>
        </p:txBody>
      </p:sp>
      <p:sp>
        <p:nvSpPr>
          <p:cNvPr id="2" name="Rectangle 1"/>
          <p:cNvSpPr/>
          <p:nvPr/>
        </p:nvSpPr>
        <p:spPr>
          <a:xfrm>
            <a:off x="150814" y="839888"/>
            <a:ext cx="1456296" cy="40902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  <a:tabLst>
                <a:tab pos="2781300" algn="r"/>
              </a:tabLst>
            </a:pPr>
            <a:r>
              <a:rPr lang="en-US" sz="12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able S2: Primer list</a:t>
            </a:r>
            <a:endParaRPr lang="en-US" sz="1200" kern="100" dirty="0"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565" y="1709549"/>
            <a:ext cx="6431837" cy="4615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184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2</TotalTime>
  <Words>430</Words>
  <Application>Microsoft Macintosh PowerPoint</Application>
  <PresentationFormat>A4 Paper (210x297 mm)</PresentationFormat>
  <Paragraphs>7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is Kao</dc:creator>
  <cp:lastModifiedBy>Microsoft Office User</cp:lastModifiedBy>
  <cp:revision>36</cp:revision>
  <dcterms:created xsi:type="dcterms:W3CDTF">2020-11-21T23:24:56Z</dcterms:created>
  <dcterms:modified xsi:type="dcterms:W3CDTF">2021-05-11T23:48:04Z</dcterms:modified>
</cp:coreProperties>
</file>